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4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824"/>
    <p:restoredTop sz="94674"/>
  </p:normalViewPr>
  <p:slideViewPr>
    <p:cSldViewPr snapToGrid="0" snapToObjects="1">
      <p:cViewPr varScale="1">
        <p:scale>
          <a:sx n="92" d="100"/>
          <a:sy n="92" d="100"/>
        </p:scale>
        <p:origin x="335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4A933-148A-8249-BCE7-3BCE134A150F}" type="datetimeFigureOut">
              <a:rPr kumimoji="1" lang="ja-JP" altLang="en-US" smtClean="0"/>
              <a:t>2026/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D1990-CA77-6040-8C6B-B20ACC21BE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90457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4A933-148A-8249-BCE7-3BCE134A150F}" type="datetimeFigureOut">
              <a:rPr kumimoji="1" lang="ja-JP" altLang="en-US" smtClean="0"/>
              <a:t>2026/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D1990-CA77-6040-8C6B-B20ACC21BE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29902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4A933-148A-8249-BCE7-3BCE134A150F}" type="datetimeFigureOut">
              <a:rPr kumimoji="1" lang="ja-JP" altLang="en-US" smtClean="0"/>
              <a:t>2026/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D1990-CA77-6040-8C6B-B20ACC21BE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74764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4A933-148A-8249-BCE7-3BCE134A150F}" type="datetimeFigureOut">
              <a:rPr kumimoji="1" lang="ja-JP" altLang="en-US" smtClean="0"/>
              <a:t>2026/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D1990-CA77-6040-8C6B-B20ACC21BE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85700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4A933-148A-8249-BCE7-3BCE134A150F}" type="datetimeFigureOut">
              <a:rPr kumimoji="1" lang="ja-JP" altLang="en-US" smtClean="0"/>
              <a:t>2026/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D1990-CA77-6040-8C6B-B20ACC21BE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21252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4A933-148A-8249-BCE7-3BCE134A150F}" type="datetimeFigureOut">
              <a:rPr kumimoji="1" lang="ja-JP" altLang="en-US" smtClean="0"/>
              <a:t>2026/1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D1990-CA77-6040-8C6B-B20ACC21BE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78679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4A933-148A-8249-BCE7-3BCE134A150F}" type="datetimeFigureOut">
              <a:rPr kumimoji="1" lang="ja-JP" altLang="en-US" smtClean="0"/>
              <a:t>2026/1/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D1990-CA77-6040-8C6B-B20ACC21BE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67712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4A933-148A-8249-BCE7-3BCE134A150F}" type="datetimeFigureOut">
              <a:rPr kumimoji="1" lang="ja-JP" altLang="en-US" smtClean="0"/>
              <a:t>2026/1/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D1990-CA77-6040-8C6B-B20ACC21BE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41480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4A933-148A-8249-BCE7-3BCE134A150F}" type="datetimeFigureOut">
              <a:rPr kumimoji="1" lang="ja-JP" altLang="en-US" smtClean="0"/>
              <a:t>2026/1/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D1990-CA77-6040-8C6B-B20ACC21BE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23181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4A933-148A-8249-BCE7-3BCE134A150F}" type="datetimeFigureOut">
              <a:rPr kumimoji="1" lang="ja-JP" altLang="en-US" smtClean="0"/>
              <a:t>2026/1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D1990-CA77-6040-8C6B-B20ACC21BE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32117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4A933-148A-8249-BCE7-3BCE134A150F}" type="datetimeFigureOut">
              <a:rPr kumimoji="1" lang="ja-JP" altLang="en-US" smtClean="0"/>
              <a:t>2026/1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D1990-CA77-6040-8C6B-B20ACC21BE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28546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04A933-148A-8249-BCE7-3BCE134A150F}" type="datetimeFigureOut">
              <a:rPr kumimoji="1" lang="ja-JP" altLang="en-US" smtClean="0"/>
              <a:t>2026/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FD1990-CA77-6040-8C6B-B20ACC21BE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82872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microsoft.com/office/2007/relationships/hdphoto" Target="../media/hdphoto2.wdp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microsoft.com/office/2007/relationships/hdphoto" Target="../media/hdphoto1.wdp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751FD185-C779-4E45-E91A-A2550C7B0A7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95457" y="2746849"/>
            <a:ext cx="1980000" cy="108810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5" name="図 44">
            <a:extLst>
              <a:ext uri="{FF2B5EF4-FFF2-40B4-BE49-F238E27FC236}">
                <a16:creationId xmlns:a16="http://schemas.microsoft.com/office/drawing/2014/main" id="{453BFF60-AC41-9F16-4EDC-BEEA27FE4DD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00574" y="4572000"/>
            <a:ext cx="2431422" cy="3031865"/>
          </a:xfrm>
          <a:prstGeom prst="rect">
            <a:avLst/>
          </a:prstGeom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CBD0A503-D6FE-F645-84AB-62AB950BC5A2}"/>
              </a:ext>
            </a:extLst>
          </p:cNvPr>
          <p:cNvSpPr txBox="1"/>
          <p:nvPr/>
        </p:nvSpPr>
        <p:spPr>
          <a:xfrm>
            <a:off x="0" y="0"/>
            <a:ext cx="7280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 S1</a:t>
            </a:r>
            <a:endParaRPr kumimoji="1" lang="ja-JP" altLang="en-US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31502B05-7589-5A4C-B13C-3E0C48790735}"/>
              </a:ext>
            </a:extLst>
          </p:cNvPr>
          <p:cNvSpPr txBox="1"/>
          <p:nvPr/>
        </p:nvSpPr>
        <p:spPr>
          <a:xfrm>
            <a:off x="1301228" y="989479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/>
              <a:t>A</a:t>
            </a:r>
            <a:endParaRPr kumimoji="1" lang="ja-JP" altLang="en-US" sz="2000" b="1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8244A75D-77A5-8F6F-5D43-8CFF929BC222}"/>
              </a:ext>
            </a:extLst>
          </p:cNvPr>
          <p:cNvSpPr txBox="1"/>
          <p:nvPr/>
        </p:nvSpPr>
        <p:spPr>
          <a:xfrm>
            <a:off x="3150081" y="969834"/>
            <a:ext cx="8707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apan-2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472A1DC4-D649-C1FE-4B02-34CCB9198D49}"/>
              </a:ext>
            </a:extLst>
          </p:cNvPr>
          <p:cNvSpPr txBox="1"/>
          <p:nvPr/>
        </p:nvSpPr>
        <p:spPr>
          <a:xfrm>
            <a:off x="1301228" y="4517605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/>
              <a:t>B</a:t>
            </a:r>
            <a:endParaRPr kumimoji="1" lang="ja-JP" altLang="en-US" sz="2000" b="1"/>
          </a:p>
        </p:txBody>
      </p:sp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id="{D6BAAC90-B95F-EB47-DC96-CA09560DE4E5}"/>
              </a:ext>
            </a:extLst>
          </p:cNvPr>
          <p:cNvCxnSpPr>
            <a:cxnSpLocks/>
          </p:cNvCxnSpPr>
          <p:nvPr/>
        </p:nvCxnSpPr>
        <p:spPr>
          <a:xfrm>
            <a:off x="2706175" y="1312067"/>
            <a:ext cx="1774356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3550E24B-6CF7-E373-7CE3-E25E50529991}"/>
              </a:ext>
            </a:extLst>
          </p:cNvPr>
          <p:cNvSpPr txBox="1"/>
          <p:nvPr/>
        </p:nvSpPr>
        <p:spPr>
          <a:xfrm>
            <a:off x="1897667" y="1344564"/>
            <a:ext cx="8723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5-FU (µg/mL)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71F72F0F-009D-8FBA-CB69-F9A996DD6B68}"/>
              </a:ext>
            </a:extLst>
          </p:cNvPr>
          <p:cNvSpPr txBox="1"/>
          <p:nvPr/>
        </p:nvSpPr>
        <p:spPr>
          <a:xfrm>
            <a:off x="2891887" y="1321481"/>
            <a:ext cx="2696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7FBB7E06-B7F7-8FBE-6789-C0589977E776}"/>
              </a:ext>
            </a:extLst>
          </p:cNvPr>
          <p:cNvSpPr txBox="1"/>
          <p:nvPr/>
        </p:nvSpPr>
        <p:spPr>
          <a:xfrm>
            <a:off x="3405242" y="1321481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2BB8D8B8-B5A6-8F3C-E393-5ABB26654D44}"/>
              </a:ext>
            </a:extLst>
          </p:cNvPr>
          <p:cNvSpPr txBox="1"/>
          <p:nvPr/>
        </p:nvSpPr>
        <p:spPr>
          <a:xfrm>
            <a:off x="3956027" y="1321481"/>
            <a:ext cx="5245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図 18">
            <a:extLst>
              <a:ext uri="{FF2B5EF4-FFF2-40B4-BE49-F238E27FC236}">
                <a16:creationId xmlns:a16="http://schemas.microsoft.com/office/drawing/2014/main" id="{7BF449CE-C3E5-9804-F443-A91F17E2729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595458" y="3874334"/>
            <a:ext cx="1980000" cy="29886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" name="図 19">
            <a:extLst>
              <a:ext uri="{FF2B5EF4-FFF2-40B4-BE49-F238E27FC236}">
                <a16:creationId xmlns:a16="http://schemas.microsoft.com/office/drawing/2014/main" id="{6D2C0718-9F7A-C786-AC5F-B569A19EC267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595457" y="1620871"/>
            <a:ext cx="1980000" cy="10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BC73E556-F053-6C8D-AECA-024C2166638A}"/>
              </a:ext>
            </a:extLst>
          </p:cNvPr>
          <p:cNvSpPr txBox="1"/>
          <p:nvPr/>
        </p:nvSpPr>
        <p:spPr>
          <a:xfrm>
            <a:off x="1681654" y="1976579"/>
            <a:ext cx="8833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IB : 11-4.1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5CF09CA5-D167-03B7-3869-4DD6BCABA6B2}"/>
              </a:ext>
            </a:extLst>
          </p:cNvPr>
          <p:cNvSpPr txBox="1"/>
          <p:nvPr/>
        </p:nvSpPr>
        <p:spPr>
          <a:xfrm>
            <a:off x="1670240" y="3106085"/>
            <a:ext cx="8947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IB : 9-10.2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94ED9E90-D09F-8C76-0F56-7447F41BF309}"/>
              </a:ext>
            </a:extLst>
          </p:cNvPr>
          <p:cNvSpPr txBox="1"/>
          <p:nvPr/>
        </p:nvSpPr>
        <p:spPr>
          <a:xfrm>
            <a:off x="1641386" y="3879795"/>
            <a:ext cx="9236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IB : β-actin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4C0822FC-4254-859A-7053-9796ADB2CDDB}"/>
              </a:ext>
            </a:extLst>
          </p:cNvPr>
          <p:cNvSpPr txBox="1"/>
          <p:nvPr/>
        </p:nvSpPr>
        <p:spPr>
          <a:xfrm>
            <a:off x="4715899" y="1695309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full-length IL-18</a:t>
            </a: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24 </a:t>
            </a:r>
            <a:r>
              <a:rPr kumimoji="1"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0E4CD0B1-232C-3130-E680-4B13F4E0E1AA}"/>
              </a:ext>
            </a:extLst>
          </p:cNvPr>
          <p:cNvSpPr txBox="1"/>
          <p:nvPr/>
        </p:nvSpPr>
        <p:spPr>
          <a:xfrm>
            <a:off x="4715899" y="2239795"/>
            <a:ext cx="9092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cleaved IL-18</a:t>
            </a: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18 </a:t>
            </a:r>
            <a:r>
              <a:rPr kumimoji="1"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84A52A48-8386-CC16-7E10-EAB0CBB17D4D}"/>
              </a:ext>
            </a:extLst>
          </p:cNvPr>
          <p:cNvSpPr txBox="1"/>
          <p:nvPr/>
        </p:nvSpPr>
        <p:spPr>
          <a:xfrm>
            <a:off x="4715899" y="3315321"/>
            <a:ext cx="9092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cleaved IL-18</a:t>
            </a: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18 </a:t>
            </a:r>
            <a:r>
              <a:rPr kumimoji="1"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129401A1-2516-3FD0-6FB3-937042CF091F}"/>
              </a:ext>
            </a:extLst>
          </p:cNvPr>
          <p:cNvSpPr txBox="1"/>
          <p:nvPr/>
        </p:nvSpPr>
        <p:spPr>
          <a:xfrm>
            <a:off x="4605879" y="3925962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42 </a:t>
            </a:r>
            <a:r>
              <a:rPr kumimoji="1"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三角形 28">
            <a:extLst>
              <a:ext uri="{FF2B5EF4-FFF2-40B4-BE49-F238E27FC236}">
                <a16:creationId xmlns:a16="http://schemas.microsoft.com/office/drawing/2014/main" id="{2BF287C5-6320-7041-576D-B9CE1D4C0AFC}"/>
              </a:ext>
            </a:extLst>
          </p:cNvPr>
          <p:cNvSpPr/>
          <p:nvPr/>
        </p:nvSpPr>
        <p:spPr>
          <a:xfrm rot="16200000">
            <a:off x="4610744" y="1819939"/>
            <a:ext cx="105479" cy="111181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" name="三角形 29">
            <a:extLst>
              <a:ext uri="{FF2B5EF4-FFF2-40B4-BE49-F238E27FC236}">
                <a16:creationId xmlns:a16="http://schemas.microsoft.com/office/drawing/2014/main" id="{C16F1203-85FB-E559-A504-A10CC4DDAA3E}"/>
              </a:ext>
            </a:extLst>
          </p:cNvPr>
          <p:cNvSpPr/>
          <p:nvPr/>
        </p:nvSpPr>
        <p:spPr>
          <a:xfrm rot="16200000">
            <a:off x="4610744" y="2367309"/>
            <a:ext cx="105479" cy="111181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" name="三角形 30">
            <a:extLst>
              <a:ext uri="{FF2B5EF4-FFF2-40B4-BE49-F238E27FC236}">
                <a16:creationId xmlns:a16="http://schemas.microsoft.com/office/drawing/2014/main" id="{6CF62E7F-DEC4-AA14-57C9-D6C43ED43E75}"/>
              </a:ext>
            </a:extLst>
          </p:cNvPr>
          <p:cNvSpPr/>
          <p:nvPr/>
        </p:nvSpPr>
        <p:spPr>
          <a:xfrm rot="16200000">
            <a:off x="4610744" y="3441114"/>
            <a:ext cx="105479" cy="111181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289C09E6-EBD4-0065-8FBB-BFC5111EF79B}"/>
              </a:ext>
            </a:extLst>
          </p:cNvPr>
          <p:cNvSpPr txBox="1"/>
          <p:nvPr/>
        </p:nvSpPr>
        <p:spPr>
          <a:xfrm>
            <a:off x="2492377" y="4696741"/>
            <a:ext cx="97013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Capan-2</a:t>
            </a:r>
            <a:endParaRPr kumimoji="1"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ECD50C91-2DEA-07F4-F2B3-7A7145FE2E9D}"/>
              </a:ext>
            </a:extLst>
          </p:cNvPr>
          <p:cNvSpPr txBox="1"/>
          <p:nvPr/>
        </p:nvSpPr>
        <p:spPr>
          <a:xfrm rot="16200000">
            <a:off x="909233" y="6041391"/>
            <a:ext cx="19239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released IL-18 protein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4EE05244-CFC9-C8C2-D423-573E7484E939}"/>
              </a:ext>
            </a:extLst>
          </p:cNvPr>
          <p:cNvSpPr txBox="1"/>
          <p:nvPr/>
        </p:nvSpPr>
        <p:spPr>
          <a:xfrm>
            <a:off x="2078628" y="4564654"/>
            <a:ext cx="40908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10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75613AFE-0750-7FD4-98B3-79330B81A705}"/>
              </a:ext>
            </a:extLst>
          </p:cNvPr>
          <p:cNvSpPr txBox="1"/>
          <p:nvPr/>
        </p:nvSpPr>
        <p:spPr>
          <a:xfrm>
            <a:off x="2078628" y="5114000"/>
            <a:ext cx="40908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08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B09788C9-E196-3709-C980-A8BA5BF9AA36}"/>
              </a:ext>
            </a:extLst>
          </p:cNvPr>
          <p:cNvSpPr txBox="1"/>
          <p:nvPr/>
        </p:nvSpPr>
        <p:spPr>
          <a:xfrm>
            <a:off x="2078628" y="5694010"/>
            <a:ext cx="40908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06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EAC4DAAF-30E5-BB42-D2C2-23D24C355ADA}"/>
              </a:ext>
            </a:extLst>
          </p:cNvPr>
          <p:cNvSpPr txBox="1"/>
          <p:nvPr/>
        </p:nvSpPr>
        <p:spPr>
          <a:xfrm>
            <a:off x="2078628" y="6260382"/>
            <a:ext cx="40908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04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FA027310-74F1-2F2D-0E6C-802D088A52BD}"/>
              </a:ext>
            </a:extLst>
          </p:cNvPr>
          <p:cNvSpPr txBox="1"/>
          <p:nvPr/>
        </p:nvSpPr>
        <p:spPr>
          <a:xfrm>
            <a:off x="2078628" y="6832847"/>
            <a:ext cx="40908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02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948D36D2-18AF-D41D-0ED8-9CACF17D0E96}"/>
              </a:ext>
            </a:extLst>
          </p:cNvPr>
          <p:cNvSpPr txBox="1"/>
          <p:nvPr/>
        </p:nvSpPr>
        <p:spPr>
          <a:xfrm>
            <a:off x="2078628" y="7409135"/>
            <a:ext cx="40908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00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416BF0B0-6ED2-DD73-A686-5ECACC9145B7}"/>
              </a:ext>
            </a:extLst>
          </p:cNvPr>
          <p:cNvSpPr txBox="1"/>
          <p:nvPr/>
        </p:nvSpPr>
        <p:spPr>
          <a:xfrm>
            <a:off x="2906677" y="7525572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E2F5F703-F649-03E5-9182-B054E479FF9A}"/>
              </a:ext>
            </a:extLst>
          </p:cNvPr>
          <p:cNvSpPr txBox="1"/>
          <p:nvPr/>
        </p:nvSpPr>
        <p:spPr>
          <a:xfrm>
            <a:off x="3930473" y="7522127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7E152339-2303-5C1D-E071-8F345D99B665}"/>
              </a:ext>
            </a:extLst>
          </p:cNvPr>
          <p:cNvSpPr txBox="1"/>
          <p:nvPr/>
        </p:nvSpPr>
        <p:spPr>
          <a:xfrm>
            <a:off x="3048703" y="7860832"/>
            <a:ext cx="1101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5-FU (µg/mL)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直線コネクタ 42">
            <a:extLst>
              <a:ext uri="{FF2B5EF4-FFF2-40B4-BE49-F238E27FC236}">
                <a16:creationId xmlns:a16="http://schemas.microsoft.com/office/drawing/2014/main" id="{C0CB58CF-6FD9-1730-DDCA-672AF92AAFF7}"/>
              </a:ext>
            </a:extLst>
          </p:cNvPr>
          <p:cNvCxnSpPr>
            <a:cxnSpLocks/>
          </p:cNvCxnSpPr>
          <p:nvPr/>
        </p:nvCxnSpPr>
        <p:spPr>
          <a:xfrm>
            <a:off x="2751146" y="7847090"/>
            <a:ext cx="1682991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7A028D8B-420A-B054-61E4-B6011F9292AD}"/>
              </a:ext>
            </a:extLst>
          </p:cNvPr>
          <p:cNvSpPr txBox="1"/>
          <p:nvPr/>
        </p:nvSpPr>
        <p:spPr>
          <a:xfrm>
            <a:off x="3949709" y="4898748"/>
            <a:ext cx="46358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28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kumimoji="1" lang="ja-JP" altLang="en-US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601794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プレゼンテーション5" id="{7F0F8FDD-CACF-9B49-9849-ECC347444CD9}" vid="{F8B94428-AAF4-3D42-9B91-A0CF5D705CD7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テーマ</Template>
  <TotalTime>910</TotalTime>
  <Words>62</Words>
  <Application>Microsoft Macintosh PowerPoint</Application>
  <PresentationFormat>画面に合わせる (4:3)</PresentationFormat>
  <Paragraphs>3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ヒロキ カミノ</dc:creator>
  <cp:lastModifiedBy>加美野　宏樹</cp:lastModifiedBy>
  <cp:revision>243</cp:revision>
  <cp:lastPrinted>2021-12-06T23:06:04Z</cp:lastPrinted>
  <dcterms:created xsi:type="dcterms:W3CDTF">2021-11-10T07:42:53Z</dcterms:created>
  <dcterms:modified xsi:type="dcterms:W3CDTF">2026-01-06T06:18:13Z</dcterms:modified>
</cp:coreProperties>
</file>